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138EB-12F1-1B47-9C2E-F8FDDDC52E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F47C8A-BE29-AA40-9803-9EBC38F4BE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F5C175-DFE4-E947-98BC-008E3A076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EBA211-90C4-784E-BC12-5CC169B97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78FE05-89C7-1A41-BF58-FFA8DDFCE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517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5AFC5-0187-5340-A7C3-36EA1015AC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40E653-F29F-8044-AE5C-C6B686B874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D9D853-F172-314B-901E-011F85A65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DA9515-161D-4344-A2C2-95FDC969E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5F0FE-DFA8-034A-8B34-7E3E05768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0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B95962-45E0-0548-AFA3-7315BB44FB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119CCB-8DC4-AF45-8EFE-2BCD947192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1D78E0-4E4E-9242-A272-F103D895D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2B9F4A-B354-CE4E-9CF1-02D0ED28E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005FF8-0BE5-F94B-8BC6-B6F4002EB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534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FAEC13-34A9-6A46-9400-07828B176E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BE41C1-DA74-EE42-A9C6-BFBA7B3DE2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C24A65-0C54-2F45-815E-FE2E02DDE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132F25-23D5-2245-A908-4644EA430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AC27C-7A7B-1D4A-829A-6189CDE08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34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E90336-309F-A64B-85D5-C00C3409DF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701415-356C-5940-B446-9320813C26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BB0C4B-BEE5-E841-8097-0D38293CF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A5AB9-EAD4-AF43-92F6-143141E9E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64E9ED-2EA9-0047-9DC5-2694021FB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830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85971-1FB5-6A4D-AC03-B51BB75BC9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AEDFF4-18D4-264E-A21F-FA9BDF0896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D2E8F6-D668-0749-895E-98E212273C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07DFA4-AE35-1046-BEAA-7126C7673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9F6DA2-3BAA-7947-A880-C349BA6DF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5DC225-B3D0-EC40-8F3E-0DBAB24D1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38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6F6C4-7280-4E49-B2FC-4C0BFA707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06DAAB-3A73-D340-9ACA-D977E5FE4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64B598-F812-6948-B9E2-771E4C34D8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D0A554C-336F-6D4E-B49B-1ECA6F5CA4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18C44D-B465-C143-9330-6EC6EA553B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1F8C9D6-AEAB-3946-9558-8ECB578BC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E7C4F9-2814-BC40-89AB-046183040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A5072C-D544-FC46-9AD2-0971F533A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185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4A709-68C3-2246-85E4-C28FB4E9D9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6832B7-95E5-3F43-8FBB-89849C285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6A206C-D7A0-B24B-B826-929006F68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16B4C6-4518-2843-9E75-D5A8C5F2A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130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D8227E-8004-974E-9D28-5DA3E583A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8CDD42-D91D-4240-9E24-76E6A374E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9409C8-D9CE-6946-B41F-8088D20057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503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D5B6F-5054-124D-A0CA-C440D29706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16A7E6-590F-BF43-A2F7-A6BBF2CEF2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7D991A-0DAC-4043-BD55-3199893C82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AEF2CC-3DD4-014E-9236-A7302F3BEA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A3FD84-E540-5546-A5DA-7313E63CC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4A3572-8FC6-AB44-8E69-248FD26D7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735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83D32A-B813-D346-8EE1-8E98B7EC3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39A22B-F597-6E4F-B7C1-D3E9562997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D88BF9-8F87-9F43-9DDD-E5E6C556D9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126CC5-A842-3A49-991D-CA3996663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AEC0F9-4CC8-0044-AA00-3F417EFE4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F8580D-F81E-C54E-A7EA-D1DA07CF4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5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7BF85F-9D41-A346-9B30-836C99E6F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19B83E-4C21-3B46-9409-B2594FC687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3ECDDA-280B-7041-AD37-ADE063E17E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B8729-7D2E-7E42-96FE-568855008FD8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3738E6-14B7-E24C-BAE5-46B15E7301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B1930D-C400-DF40-94D6-9C19856B50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13F18-0223-184C-9BBB-708A51B48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732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5AD4B75-E129-C04A-A294-D2D13E1E08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6771659"/>
              </p:ext>
            </p:extLst>
          </p:nvPr>
        </p:nvGraphicFramePr>
        <p:xfrm>
          <a:off x="2236573" y="534052"/>
          <a:ext cx="5931244" cy="604603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965622">
                  <a:extLst>
                    <a:ext uri="{9D8B030D-6E8A-4147-A177-3AD203B41FA5}">
                      <a16:colId xmlns:a16="http://schemas.microsoft.com/office/drawing/2014/main" val="4040158605"/>
                    </a:ext>
                  </a:extLst>
                </a:gridCol>
                <a:gridCol w="2965622">
                  <a:extLst>
                    <a:ext uri="{9D8B030D-6E8A-4147-A177-3AD203B41FA5}">
                      <a16:colId xmlns:a16="http://schemas.microsoft.com/office/drawing/2014/main" val="414801422"/>
                    </a:ext>
                  </a:extLst>
                </a:gridCol>
              </a:tblGrid>
              <a:tr h="34839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PDB accession number: 7KE0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3124273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Data Collection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7990904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Wavelength (Å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1.541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486767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Space group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dirty="0">
                          <a:solidFill>
                            <a:schemeClr val="tx1"/>
                          </a:solidFill>
                          <a:effectLst/>
                        </a:rPr>
                        <a:t>P 31  2 1</a:t>
                      </a:r>
                      <a:endParaRPr lang="en-US" sz="13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4432457"/>
                  </a:ext>
                </a:extLst>
              </a:tr>
              <a:tr h="34839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Unit cell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dirty="0">
                          <a:solidFill>
                            <a:schemeClr val="tx1"/>
                          </a:solidFill>
                          <a:effectLst/>
                        </a:rPr>
                        <a:t>71.932, 71.932, 65.87, 90, 90, 120</a:t>
                      </a:r>
                      <a:endParaRPr lang="en-US" sz="13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520839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Resolution (Å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24.0 – 2.20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6880865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R-meas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0.103 (0.623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8988098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I/sigma(I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dirty="0">
                          <a:solidFill>
                            <a:schemeClr val="tx1"/>
                          </a:solidFill>
                          <a:effectLst/>
                        </a:rPr>
                        <a:t>22.0 (2.22)</a:t>
                      </a:r>
                      <a:endParaRPr lang="en-US" sz="13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93512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Completeness (%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99.7 (99.5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9254340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Redundancy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8.8 (6.2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3917252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8364530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Refinement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2926364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Resolution (Å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23.55 – 2.19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1781030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Number of reflections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17510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5459323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Rwork/Rfree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0.2503/0.2690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6925447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Number of Atoms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8472001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Protein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1035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9182736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Ligand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35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8969450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Water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29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4333889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B-factor (Å</a:t>
                      </a:r>
                      <a:r>
                        <a:rPr lang="en-US" sz="1300" baseline="30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6131015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Protein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38.00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1307028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Ligands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37.77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5131240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Water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38.22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2139309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R.m.s deviations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2551093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Bond lengths (Å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0.003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348398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Bond angles (</a:t>
                      </a: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</a:t>
                      </a: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0.655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4028594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Ramachandran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3583504"/>
                  </a:ext>
                </a:extLst>
              </a:tr>
              <a:tr h="1741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Favored (%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99.2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72186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chemeClr val="tx1"/>
                          </a:solidFill>
                          <a:effectLst/>
                        </a:rPr>
                        <a:t>     Ouliers (%)</a:t>
                      </a:r>
                      <a:endParaRPr lang="en-US" sz="13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US" sz="13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267" marR="562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1426975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DF8D92F7-EB7E-7A49-84F1-302617483A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5546" y="133942"/>
            <a:ext cx="784336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able </a:t>
            </a:r>
            <a:r>
              <a:rPr kumimoji="0" lang="en-US" altLang="en-US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1: Data collection and refinement </a:t>
            </a:r>
            <a:r>
              <a:rPr lang="en-US" altLang="en-US" sz="2000" b="1" dirty="0">
                <a:latin typeface="Arial" panose="020B0604020202020204" pitchFamily="34" charset="0"/>
                <a:ea typeface="Times New Roman" panose="02020603050405020304" pitchFamily="18" charset="0"/>
              </a:rPr>
              <a:t>s</a:t>
            </a:r>
            <a:r>
              <a:rPr kumimoji="0" lang="en-US" altLang="en-US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atistics.</a:t>
            </a:r>
            <a:endParaRPr kumimoji="0" lang="en-US" altLang="en-US" sz="2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E7D0017-E591-2E4E-9432-CC2A379FABD3}"/>
              </a:ext>
            </a:extLst>
          </p:cNvPr>
          <p:cNvSpPr/>
          <p:nvPr/>
        </p:nvSpPr>
        <p:spPr>
          <a:xfrm>
            <a:off x="8269289" y="6118419"/>
            <a:ext cx="372912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Statistics for highest resolution shells shown in parentheses.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346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1</Words>
  <Application>Microsoft Macintosh PowerPoint</Application>
  <PresentationFormat>Widescreen</PresentationFormat>
  <Paragraphs>6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21-06-11T14:34:31Z</dcterms:created>
  <dcterms:modified xsi:type="dcterms:W3CDTF">2021-06-11T14:36:49Z</dcterms:modified>
</cp:coreProperties>
</file>